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A8FC1E-8995-4D59-BD85-93A622C75F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09FD6B-53A4-4CE9-B8CF-D9362500E0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348224-6510-448A-9580-9D1BAA5873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CBD62-3C0B-439D-8483-D0C8893380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79053E-568F-4B2C-80ED-42CD5D30BD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A8278-6769-4B91-8D3E-45C9855125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5C621-0D66-4660-9FED-C69345BE0A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58AF45-53CA-4C8E-B4DD-2CEA9324FA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65B56-AAC8-45E1-900D-DF4FC7BA68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7A5ABD-50C9-4A7F-8567-CC18F8BC63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893AF-C549-49EE-924E-B5D3CAC300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70719A-2853-4DDF-87EE-4EBE93FDC4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297D81-C46B-4F73-A5A9-60329C5FE3C2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250920" y="3933720"/>
            <a:ext cx="889308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S5 Fig. miR-142-3p modulates expression levels, but not subcellular distribution of N-WASP in MDA-MB-468 cells.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Following transfection</a:t>
            </a:r>
            <a:r>
              <a:rPr b="1" lang="de-DE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with a negative control miRNA, miR-142-3p precursors or an antimiR-142-3p (all from ABI), cells were processed for immunohistochemistry as described in the main manuscript using rabbit-anti-N-WASP (Cell signaling, 1:100) and appropriate ALEXA488-labeled secondary antibodies (Invitrogen, 1:600). N-WASP localizes to the cell periphery and to regions of cell-cell contact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5"/>
          <p:cNvGraphicFramePr/>
          <p:nvPr/>
        </p:nvGraphicFramePr>
        <p:xfrm>
          <a:off x="179280" y="95400"/>
          <a:ext cx="8713800" cy="3327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9280" y="95400"/>
                    <a:ext cx="8713800" cy="3327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9-05T06:18:10Z</dcterms:created>
  <dc:creator>Martin Götte</dc:creator>
  <dc:description/>
  <dc:language>en-US</dc:language>
  <cp:lastModifiedBy>Prof. Dr. Martin Götte</cp:lastModifiedBy>
  <dcterms:modified xsi:type="dcterms:W3CDTF">2015-11-16T14:56:34Z</dcterms:modified>
  <cp:revision>10</cp:revision>
  <dc:subject/>
  <dc:title>Folie 1</dc:title>
</cp:coreProperties>
</file>